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Fluconazo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197664304484092E-2"/>
          <c:y val="2.507122507122507E-2"/>
          <c:w val="0.82754818278338982"/>
          <c:h val="0.71671705139421671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Graph!$D$20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FF00FF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G$21:$G$35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5.9144254965726768</c:v>
                  </c:pt>
                  <c:pt idx="7">
                    <c:v>2.1011909272387763</c:v>
                  </c:pt>
                  <c:pt idx="8">
                    <c:v>1.6495721976846514</c:v>
                  </c:pt>
                  <c:pt idx="9">
                    <c:v>1.7404671430534633E-14</c:v>
                  </c:pt>
                  <c:pt idx="10">
                    <c:v>2.1226112837853863</c:v>
                  </c:pt>
                  <c:pt idx="11">
                    <c:v>1.4416929111997554</c:v>
                  </c:pt>
                  <c:pt idx="12">
                    <c:v>3.3105251615784552</c:v>
                  </c:pt>
                  <c:pt idx="13">
                    <c:v>1.3036941562346429</c:v>
                  </c:pt>
                  <c:pt idx="14">
                    <c:v>3.6740471675703437</c:v>
                  </c:pt>
                </c:numCache>
              </c:numRef>
            </c:plus>
            <c:minus>
              <c:numRef>
                <c:f>Graph!$G$21:$G$35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5.9144254965726768</c:v>
                  </c:pt>
                  <c:pt idx="7">
                    <c:v>2.1011909272387763</c:v>
                  </c:pt>
                  <c:pt idx="8">
                    <c:v>1.6495721976846514</c:v>
                  </c:pt>
                  <c:pt idx="9">
                    <c:v>1.7404671430534633E-14</c:v>
                  </c:pt>
                  <c:pt idx="10">
                    <c:v>2.1226112837853863</c:v>
                  </c:pt>
                  <c:pt idx="11">
                    <c:v>1.4416929111997554</c:v>
                  </c:pt>
                  <c:pt idx="12">
                    <c:v>3.3105251615784552</c:v>
                  </c:pt>
                  <c:pt idx="13">
                    <c:v>1.3036941562346429</c:v>
                  </c:pt>
                  <c:pt idx="14">
                    <c:v>3.6740471675703437</c:v>
                  </c:pt>
                </c:numCache>
              </c:numRef>
            </c:minus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1:$D$35</c:f>
              <c:numCache>
                <c:formatCode>0.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5.894428152492665</c:v>
                </c:pt>
                <c:pt idx="7">
                  <c:v>97.574955908289255</c:v>
                </c:pt>
                <c:pt idx="8">
                  <c:v>53.333333333333336</c:v>
                </c:pt>
                <c:pt idx="9">
                  <c:v>92.592592592592567</c:v>
                </c:pt>
                <c:pt idx="10">
                  <c:v>58.026960784313722</c:v>
                </c:pt>
                <c:pt idx="11">
                  <c:v>61.568627450980394</c:v>
                </c:pt>
                <c:pt idx="12">
                  <c:v>53.063725490196077</c:v>
                </c:pt>
                <c:pt idx="13">
                  <c:v>61.971326164874547</c:v>
                </c:pt>
                <c:pt idx="14">
                  <c:v>63.6363636363636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17A-41BF-A592-1559088A1702}"/>
            </c:ext>
          </c:extLst>
        </c:ser>
        <c:ser>
          <c:idx val="6"/>
          <c:order val="1"/>
          <c:tx>
            <c:strRef>
              <c:f>Graph!$F$20</c:f>
              <c:strCache>
                <c:ptCount val="1"/>
                <c:pt idx="0">
                  <c:v>25 µg/ml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G$21:$G$35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5.9144254965726768</c:v>
                  </c:pt>
                  <c:pt idx="7">
                    <c:v>2.1011909272387763</c:v>
                  </c:pt>
                  <c:pt idx="8">
                    <c:v>1.6495721976846514</c:v>
                  </c:pt>
                  <c:pt idx="9">
                    <c:v>1.7404671430534633E-14</c:v>
                  </c:pt>
                  <c:pt idx="10">
                    <c:v>2.1226112837853863</c:v>
                  </c:pt>
                  <c:pt idx="11">
                    <c:v>1.4416929111997554</c:v>
                  </c:pt>
                  <c:pt idx="12">
                    <c:v>3.3105251615784552</c:v>
                  </c:pt>
                  <c:pt idx="13">
                    <c:v>1.3036941562346429</c:v>
                  </c:pt>
                  <c:pt idx="14">
                    <c:v>3.6740471675703437</c:v>
                  </c:pt>
                </c:numCache>
              </c:numRef>
            </c:plus>
            <c:minus>
              <c:numRef>
                <c:f>Graph!$G$21:$G$35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5.9144254965726768</c:v>
                  </c:pt>
                  <c:pt idx="7">
                    <c:v>2.1011909272387763</c:v>
                  </c:pt>
                  <c:pt idx="8">
                    <c:v>1.6495721976846514</c:v>
                  </c:pt>
                  <c:pt idx="9">
                    <c:v>1.7404671430534633E-14</c:v>
                  </c:pt>
                  <c:pt idx="10">
                    <c:v>2.1226112837853863</c:v>
                  </c:pt>
                  <c:pt idx="11">
                    <c:v>1.4416929111997554</c:v>
                  </c:pt>
                  <c:pt idx="12">
                    <c:v>3.3105251615784552</c:v>
                  </c:pt>
                  <c:pt idx="13">
                    <c:v>1.3036941562346429</c:v>
                  </c:pt>
                  <c:pt idx="14">
                    <c:v>3.6740471675703437</c:v>
                  </c:pt>
                </c:numCache>
              </c:numRef>
            </c:minus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1:$F$35</c:f>
              <c:numCache>
                <c:formatCode>0.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0.612577386770951</c:v>
                </c:pt>
                <c:pt idx="7">
                  <c:v>97.574955908289255</c:v>
                </c:pt>
                <c:pt idx="8">
                  <c:v>61.904761904761905</c:v>
                </c:pt>
                <c:pt idx="9">
                  <c:v>92.592592592592567</c:v>
                </c:pt>
                <c:pt idx="10">
                  <c:v>60.049019607843142</c:v>
                </c:pt>
                <c:pt idx="11">
                  <c:v>61.540616246498608</c:v>
                </c:pt>
                <c:pt idx="12">
                  <c:v>59.252450980392155</c:v>
                </c:pt>
                <c:pt idx="13">
                  <c:v>68.494623655913983</c:v>
                </c:pt>
                <c:pt idx="14">
                  <c:v>65.7575757575757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17A-41BF-A592-1559088A1702}"/>
            </c:ext>
          </c:extLst>
        </c:ser>
        <c:ser>
          <c:idx val="1"/>
          <c:order val="2"/>
          <c:tx>
            <c:strRef>
              <c:f>Graph!$H$20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!$I$21:$I$35</c:f>
                <c:numCache>
                  <c:formatCode>General</c:formatCode>
                  <c:ptCount val="15"/>
                  <c:pt idx="0">
                    <c:v>8.8191710368819649</c:v>
                  </c:pt>
                  <c:pt idx="1">
                    <c:v>2.6943012562182562</c:v>
                  </c:pt>
                  <c:pt idx="2">
                    <c:v>2.4056261216234351</c:v>
                  </c:pt>
                  <c:pt idx="3">
                    <c:v>3.7527767497325675</c:v>
                  </c:pt>
                  <c:pt idx="4">
                    <c:v>3.8653246361229994</c:v>
                  </c:pt>
                  <c:pt idx="5">
                    <c:v>17.277733072442025</c:v>
                  </c:pt>
                  <c:pt idx="6">
                    <c:v>7.1879547692772192</c:v>
                  </c:pt>
                  <c:pt idx="7">
                    <c:v>4.12393049421161</c:v>
                  </c:pt>
                  <c:pt idx="8">
                    <c:v>1.4869042853329473</c:v>
                  </c:pt>
                  <c:pt idx="9">
                    <c:v>4.2766686606638933</c:v>
                  </c:pt>
                  <c:pt idx="10">
                    <c:v>7.2168783648703219</c:v>
                  </c:pt>
                  <c:pt idx="11">
                    <c:v>7.1903185097816698</c:v>
                  </c:pt>
                  <c:pt idx="12">
                    <c:v>2.7845216364784626</c:v>
                  </c:pt>
                  <c:pt idx="13">
                    <c:v>1.9245008972987498</c:v>
                  </c:pt>
                  <c:pt idx="14">
                    <c:v>41.629164206984605</c:v>
                  </c:pt>
                </c:numCache>
              </c:numRef>
            </c:plus>
            <c:minus>
              <c:numRef>
                <c:f>Graph!$I$21:$I$36</c:f>
                <c:numCache>
                  <c:formatCode>General</c:formatCode>
                  <c:ptCount val="16"/>
                  <c:pt idx="0">
                    <c:v>8.8191710368819649</c:v>
                  </c:pt>
                  <c:pt idx="1">
                    <c:v>2.6943012562182562</c:v>
                  </c:pt>
                  <c:pt idx="2">
                    <c:v>2.4056261216234351</c:v>
                  </c:pt>
                  <c:pt idx="3">
                    <c:v>3.7527767497325675</c:v>
                  </c:pt>
                  <c:pt idx="4">
                    <c:v>3.8653246361229994</c:v>
                  </c:pt>
                  <c:pt idx="5">
                    <c:v>17.277733072442025</c:v>
                  </c:pt>
                  <c:pt idx="6">
                    <c:v>7.1879547692772192</c:v>
                  </c:pt>
                  <c:pt idx="7">
                    <c:v>4.12393049421161</c:v>
                  </c:pt>
                  <c:pt idx="8">
                    <c:v>1.4869042853329473</c:v>
                  </c:pt>
                  <c:pt idx="9">
                    <c:v>4.2766686606638933</c:v>
                  </c:pt>
                  <c:pt idx="10">
                    <c:v>7.2168783648703219</c:v>
                  </c:pt>
                  <c:pt idx="11">
                    <c:v>7.1903185097816698</c:v>
                  </c:pt>
                  <c:pt idx="12">
                    <c:v>2.7845216364784626</c:v>
                  </c:pt>
                  <c:pt idx="13">
                    <c:v>1.9245008972987498</c:v>
                  </c:pt>
                  <c:pt idx="14">
                    <c:v>41.629164206984605</c:v>
                  </c:pt>
                </c:numCache>
              </c:numRef>
            </c:minus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1:$H$35</c:f>
              <c:numCache>
                <c:formatCode>0.0</c:formatCode>
                <c:ptCount val="15"/>
                <c:pt idx="0">
                  <c:v>76.666666666666671</c:v>
                </c:pt>
                <c:pt idx="1">
                  <c:v>84.8888888888889</c:v>
                </c:pt>
                <c:pt idx="2">
                  <c:v>86.111111111111128</c:v>
                </c:pt>
                <c:pt idx="3">
                  <c:v>83.833333333333329</c:v>
                </c:pt>
                <c:pt idx="4">
                  <c:v>77.139208173690932</c:v>
                </c:pt>
                <c:pt idx="5">
                  <c:v>83.655913978494624</c:v>
                </c:pt>
                <c:pt idx="6">
                  <c:v>92.674731182795696</c:v>
                </c:pt>
                <c:pt idx="7">
                  <c:v>95.238095238095241</c:v>
                </c:pt>
                <c:pt idx="8">
                  <c:v>75.476190476190467</c:v>
                </c:pt>
                <c:pt idx="9">
                  <c:v>93.827160493827151</c:v>
                </c:pt>
                <c:pt idx="10">
                  <c:v>79.166666666666671</c:v>
                </c:pt>
                <c:pt idx="11">
                  <c:v>73.333333333333329</c:v>
                </c:pt>
                <c:pt idx="12">
                  <c:v>74.495967741935473</c:v>
                </c:pt>
                <c:pt idx="13">
                  <c:v>81.1111111111111</c:v>
                </c:pt>
                <c:pt idx="14">
                  <c:v>48.039215686274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17A-41BF-A592-1559088A1702}"/>
            </c:ext>
          </c:extLst>
        </c:ser>
        <c:ser>
          <c:idx val="5"/>
          <c:order val="3"/>
          <c:tx>
            <c:strRef>
              <c:f>Graph!$J$20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1:$K$35</c:f>
                <c:numCache>
                  <c:formatCode>General</c:formatCode>
                  <c:ptCount val="15"/>
                  <c:pt idx="0">
                    <c:v>1.9245008972987498</c:v>
                  </c:pt>
                  <c:pt idx="1">
                    <c:v>8.2332883489549289</c:v>
                  </c:pt>
                  <c:pt idx="2">
                    <c:v>0.28867513459482108</c:v>
                  </c:pt>
                  <c:pt idx="3">
                    <c:v>1.9245008972987581</c:v>
                  </c:pt>
                  <c:pt idx="4">
                    <c:v>6.1156089132138849</c:v>
                  </c:pt>
                  <c:pt idx="5">
                    <c:v>5.596565023515315</c:v>
                  </c:pt>
                  <c:pt idx="6">
                    <c:v>1.7758347125972844</c:v>
                  </c:pt>
                  <c:pt idx="7">
                    <c:v>4.2002995774377476</c:v>
                  </c:pt>
                  <c:pt idx="8">
                    <c:v>1.2830005981991721</c:v>
                  </c:pt>
                  <c:pt idx="9">
                    <c:v>2.1383343303319506</c:v>
                  </c:pt>
                  <c:pt idx="10">
                    <c:v>0</c:v>
                  </c:pt>
                  <c:pt idx="11">
                    <c:v>0.33961780540566511</c:v>
                  </c:pt>
                  <c:pt idx="12">
                    <c:v>5.9997484302388395</c:v>
                  </c:pt>
                  <c:pt idx="13">
                    <c:v>1.552016852660284</c:v>
                  </c:pt>
                  <c:pt idx="14">
                    <c:v>2.5326528459418922</c:v>
                  </c:pt>
                </c:numCache>
              </c:numRef>
            </c:plus>
            <c:minus>
              <c:numRef>
                <c:f>Graph!$K$21:$K$35</c:f>
                <c:numCache>
                  <c:formatCode>General</c:formatCode>
                  <c:ptCount val="15"/>
                  <c:pt idx="0">
                    <c:v>1.9245008972987498</c:v>
                  </c:pt>
                  <c:pt idx="1">
                    <c:v>8.2332883489549289</c:v>
                  </c:pt>
                  <c:pt idx="2">
                    <c:v>0.28867513459482108</c:v>
                  </c:pt>
                  <c:pt idx="3">
                    <c:v>1.9245008972987581</c:v>
                  </c:pt>
                  <c:pt idx="4">
                    <c:v>6.1156089132138849</c:v>
                  </c:pt>
                  <c:pt idx="5">
                    <c:v>5.596565023515315</c:v>
                  </c:pt>
                  <c:pt idx="6">
                    <c:v>1.7758347125972844</c:v>
                  </c:pt>
                  <c:pt idx="7">
                    <c:v>4.2002995774377476</c:v>
                  </c:pt>
                  <c:pt idx="8">
                    <c:v>1.2830005981991721</c:v>
                  </c:pt>
                  <c:pt idx="9">
                    <c:v>2.1383343303319506</c:v>
                  </c:pt>
                  <c:pt idx="10">
                    <c:v>0</c:v>
                  </c:pt>
                  <c:pt idx="11">
                    <c:v>0.33961780540566511</c:v>
                  </c:pt>
                  <c:pt idx="12">
                    <c:v>5.9997484302388395</c:v>
                  </c:pt>
                  <c:pt idx="13">
                    <c:v>1.552016852660284</c:v>
                  </c:pt>
                  <c:pt idx="14">
                    <c:v>2.5326528459418922</c:v>
                  </c:pt>
                </c:numCache>
              </c:numRef>
            </c:minus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1:$J$35</c:f>
              <c:numCache>
                <c:formatCode>0.0</c:formatCode>
                <c:ptCount val="15"/>
                <c:pt idx="0">
                  <c:v>82.222222222222214</c:v>
                </c:pt>
                <c:pt idx="1">
                  <c:v>86.6111111111111</c:v>
                </c:pt>
                <c:pt idx="2">
                  <c:v>87.666666666666671</c:v>
                </c:pt>
                <c:pt idx="3">
                  <c:v>82.222222222222229</c:v>
                </c:pt>
                <c:pt idx="4">
                  <c:v>78.26898516553689</c:v>
                </c:pt>
                <c:pt idx="5">
                  <c:v>83.548387096774192</c:v>
                </c:pt>
                <c:pt idx="6">
                  <c:v>95.799731182795696</c:v>
                </c:pt>
                <c:pt idx="7">
                  <c:v>98.85361552028219</c:v>
                </c:pt>
                <c:pt idx="8">
                  <c:v>78.518518518518519</c:v>
                </c:pt>
                <c:pt idx="9">
                  <c:v>97.530864197530875</c:v>
                </c:pt>
                <c:pt idx="10">
                  <c:v>78.125</c:v>
                </c:pt>
                <c:pt idx="11">
                  <c:v>79.803921568627445</c:v>
                </c:pt>
                <c:pt idx="12">
                  <c:v>77.956989247311824</c:v>
                </c:pt>
                <c:pt idx="13">
                  <c:v>82.437275985663078</c:v>
                </c:pt>
                <c:pt idx="14">
                  <c:v>73.809523809523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17A-41BF-A592-1559088A1702}"/>
            </c:ext>
          </c:extLst>
        </c:ser>
        <c:ser>
          <c:idx val="9"/>
          <c:order val="4"/>
          <c:tx>
            <c:strRef>
              <c:f>Graph!$L$20</c:f>
              <c:strCache>
                <c:ptCount val="1"/>
                <c:pt idx="0">
                  <c:v>1 µg/ml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M$21:$M$34</c:f>
                <c:numCache>
                  <c:formatCode>General</c:formatCode>
                  <c:ptCount val="14"/>
                  <c:pt idx="0">
                    <c:v>3.3333333333333286</c:v>
                  </c:pt>
                  <c:pt idx="1">
                    <c:v>4.5225771086520572</c:v>
                  </c:pt>
                  <c:pt idx="2">
                    <c:v>2.3154073315749621</c:v>
                  </c:pt>
                  <c:pt idx="3">
                    <c:v>2.1169509870286305</c:v>
                  </c:pt>
                  <c:pt idx="4">
                    <c:v>3.3428867262739832</c:v>
                  </c:pt>
                  <c:pt idx="5">
                    <c:v>1.9865815714051622</c:v>
                  </c:pt>
                  <c:pt idx="6">
                    <c:v>3.6666398144099182</c:v>
                  </c:pt>
                  <c:pt idx="7">
                    <c:v>4.2002995774377476</c:v>
                  </c:pt>
                  <c:pt idx="8">
                    <c:v>1.5204161952911091</c:v>
                  </c:pt>
                  <c:pt idx="9">
                    <c:v>0</c:v>
                  </c:pt>
                  <c:pt idx="10">
                    <c:v>1.8042195912175805</c:v>
                  </c:pt>
                  <c:pt idx="11">
                    <c:v>1.4555048803099839</c:v>
                  </c:pt>
                  <c:pt idx="12">
                    <c:v>3.5502385504603957</c:v>
                  </c:pt>
                  <c:pt idx="13">
                    <c:v>3.1207504732674169</c:v>
                  </c:pt>
                </c:numCache>
              </c:numRef>
            </c:plus>
            <c:minus>
              <c:numRef>
                <c:f>Graph!$M$21:$M$35</c:f>
                <c:numCache>
                  <c:formatCode>General</c:formatCode>
                  <c:ptCount val="15"/>
                  <c:pt idx="0">
                    <c:v>3.3333333333333286</c:v>
                  </c:pt>
                  <c:pt idx="1">
                    <c:v>4.5225771086520572</c:v>
                  </c:pt>
                  <c:pt idx="2">
                    <c:v>2.3154073315749621</c:v>
                  </c:pt>
                  <c:pt idx="3">
                    <c:v>2.1169509870286305</c:v>
                  </c:pt>
                  <c:pt idx="4">
                    <c:v>3.3428867262739832</c:v>
                  </c:pt>
                  <c:pt idx="5">
                    <c:v>1.9865815714051622</c:v>
                  </c:pt>
                  <c:pt idx="6">
                    <c:v>3.6666398144099182</c:v>
                  </c:pt>
                  <c:pt idx="7">
                    <c:v>4.2002995774377476</c:v>
                  </c:pt>
                  <c:pt idx="8">
                    <c:v>1.5204161952911091</c:v>
                  </c:pt>
                  <c:pt idx="9">
                    <c:v>0</c:v>
                  </c:pt>
                  <c:pt idx="10">
                    <c:v>1.8042195912175805</c:v>
                  </c:pt>
                  <c:pt idx="11">
                    <c:v>1.4555048803099839</c:v>
                  </c:pt>
                  <c:pt idx="12">
                    <c:v>3.5502385504603957</c:v>
                  </c:pt>
                  <c:pt idx="13">
                    <c:v>3.1207504732674169</c:v>
                  </c:pt>
                  <c:pt idx="14">
                    <c:v>0.24258414671832518</c:v>
                  </c:pt>
                </c:numCache>
              </c:numRef>
            </c:minus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1:$L$35</c:f>
              <c:numCache>
                <c:formatCode>0.0</c:formatCode>
                <c:ptCount val="15"/>
                <c:pt idx="0">
                  <c:v>90</c:v>
                </c:pt>
                <c:pt idx="1">
                  <c:v>90.611111111111128</c:v>
                </c:pt>
                <c:pt idx="2">
                  <c:v>93.166666666666671</c:v>
                </c:pt>
                <c:pt idx="3">
                  <c:v>90.444444444444457</c:v>
                </c:pt>
                <c:pt idx="4">
                  <c:v>92.753053672593907</c:v>
                </c:pt>
                <c:pt idx="5">
                  <c:v>94.480286738351253</c:v>
                </c:pt>
                <c:pt idx="6">
                  <c:v>98.991935483870975</c:v>
                </c:pt>
                <c:pt idx="7">
                  <c:v>98.85361552028219</c:v>
                </c:pt>
                <c:pt idx="8">
                  <c:v>87.857142857142847</c:v>
                </c:pt>
                <c:pt idx="9">
                  <c:v>100</c:v>
                </c:pt>
                <c:pt idx="10">
                  <c:v>91.666666666666671</c:v>
                </c:pt>
                <c:pt idx="11">
                  <c:v>86.554621848739487</c:v>
                </c:pt>
                <c:pt idx="12">
                  <c:v>92.674731182795696</c:v>
                </c:pt>
                <c:pt idx="13">
                  <c:v>90.143369175627242</c:v>
                </c:pt>
                <c:pt idx="14">
                  <c:v>85.4341736694677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17A-41BF-A592-1559088A1702}"/>
            </c:ext>
          </c:extLst>
        </c:ser>
        <c:ser>
          <c:idx val="0"/>
          <c:order val="5"/>
          <c:tx>
            <c:strRef>
              <c:f>Graph!$N$20</c:f>
              <c:strCache>
                <c:ptCount val="1"/>
                <c:pt idx="0">
                  <c:v>0 µg/m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</c:spPr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N$21:$N$35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010-4D10-AA57-6795FA45D5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1482360"/>
        <c:axId val="341476088"/>
      </c:barChart>
      <c:catAx>
        <c:axId val="3414823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/>
            </a:pPr>
            <a:endParaRPr lang="it-IT"/>
          </a:p>
        </c:txPr>
        <c:crossAx val="341476088"/>
        <c:crosses val="autoZero"/>
        <c:auto val="1"/>
        <c:lblAlgn val="ctr"/>
        <c:lblOffset val="100"/>
        <c:noMultiLvlLbl val="0"/>
      </c:catAx>
      <c:valAx>
        <c:axId val="3414760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Colony diameter (%  elative to control)</a:t>
                </a:r>
              </a:p>
            </c:rich>
          </c:tx>
          <c:layout>
            <c:manualLayout>
              <c:xMode val="edge"/>
              <c:yMode val="edge"/>
              <c:x val="1.1981174058022306E-2"/>
              <c:y val="0.2578115171500998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341482360"/>
        <c:crosses val="autoZero"/>
        <c:crossBetween val="between"/>
      </c:valAx>
      <c:spPr>
        <a:noFill/>
        <a:ln>
          <a:noFill/>
        </a:ln>
      </c:spPr>
    </c:plotArea>
    <c:legend>
      <c:legendPos val="r"/>
      <c:layout/>
      <c:overlay val="0"/>
      <c:txPr>
        <a:bodyPr/>
        <a:lstStyle/>
        <a:p>
          <a:pPr>
            <a:defRPr sz="800"/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txPr>
    <a:bodyPr/>
    <a:lstStyle/>
    <a:p>
      <a:pPr>
        <a:defRPr sz="800"/>
      </a:pPr>
      <a:endParaRPr lang="it-IT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803</cdr:x>
      <cdr:y>0.19316</cdr:y>
    </cdr:from>
    <cdr:to>
      <cdr:x>0.09371</cdr:x>
      <cdr:y>0.23931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504781" y="1076325"/>
          <a:ext cx="190544" cy="2571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7703</cdr:x>
      <cdr:y>0.19316</cdr:y>
    </cdr:from>
    <cdr:to>
      <cdr:x>0.10526</cdr:x>
      <cdr:y>0.2359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571561" y="1076325"/>
          <a:ext cx="209489" cy="2381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2709</cdr:x>
      <cdr:y>0.17948</cdr:y>
    </cdr:from>
    <cdr:to>
      <cdr:x>0.14378</cdr:x>
      <cdr:y>0.22222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942996" y="1000098"/>
          <a:ext cx="123840" cy="2381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2195</cdr:x>
      <cdr:y>0.11452</cdr:y>
    </cdr:from>
    <cdr:to>
      <cdr:x>0.17201</cdr:x>
      <cdr:y>0.18803</cdr:y>
    </cdr:to>
    <cdr:sp macro="" textlink="">
      <cdr:nvSpPr>
        <cdr:cNvPr id="8" name="CasellaDiTesto 7"/>
        <cdr:cNvSpPr txBox="1"/>
      </cdr:nvSpPr>
      <cdr:spPr>
        <a:xfrm xmlns:a="http://schemas.openxmlformats.org/drawingml/2006/main" rot="16200000">
          <a:off x="885796" y="657228"/>
          <a:ext cx="409607" cy="3714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 </a:t>
          </a:r>
        </a:p>
      </cdr:txBody>
    </cdr:sp>
  </cdr:relSizeAnchor>
  <cdr:relSizeAnchor xmlns:cdr="http://schemas.openxmlformats.org/drawingml/2006/chartDrawing">
    <cdr:from>
      <cdr:x>0.13992</cdr:x>
      <cdr:y>0.15897</cdr:y>
    </cdr:from>
    <cdr:to>
      <cdr:x>0.19769</cdr:x>
      <cdr:y>0.20513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1038225" y="885824"/>
          <a:ext cx="428625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18229</cdr:x>
      <cdr:y>0.17265</cdr:y>
    </cdr:from>
    <cdr:to>
      <cdr:x>0.22465</cdr:x>
      <cdr:y>0.22564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352550" y="962025"/>
          <a:ext cx="314325" cy="2952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8485</cdr:x>
      <cdr:y>0.15556</cdr:y>
    </cdr:from>
    <cdr:to>
      <cdr:x>0.21309</cdr:x>
      <cdr:y>0.22564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371601" y="866775"/>
          <a:ext cx="209522" cy="3905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3492</cdr:x>
      <cdr:y>0.17949</cdr:y>
    </cdr:from>
    <cdr:to>
      <cdr:x>0.26316</cdr:x>
      <cdr:y>0.22906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743075" y="1000125"/>
          <a:ext cx="209565" cy="2762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4134</cdr:x>
      <cdr:y>0.16581</cdr:y>
    </cdr:from>
    <cdr:to>
      <cdr:x>0.2914</cdr:x>
      <cdr:y>0.25128</cdr:y>
    </cdr:to>
    <cdr:sp macro="" textlink="">
      <cdr:nvSpPr>
        <cdr:cNvPr id="14" name="CasellaDiTesto 13"/>
        <cdr:cNvSpPr txBox="1"/>
      </cdr:nvSpPr>
      <cdr:spPr>
        <a:xfrm xmlns:a="http://schemas.openxmlformats.org/drawingml/2006/main" rot="16200000">
          <a:off x="1738335" y="976310"/>
          <a:ext cx="476250" cy="3714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25032</cdr:x>
      <cdr:y>0.14701</cdr:y>
    </cdr:from>
    <cdr:to>
      <cdr:x>0.27728</cdr:x>
      <cdr:y>0.19658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1857375" y="819150"/>
          <a:ext cx="200035" cy="2762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068</cdr:x>
      <cdr:y>0.12821</cdr:y>
    </cdr:from>
    <cdr:to>
      <cdr:x>0.34275</cdr:x>
      <cdr:y>0.17265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2276475" y="714376"/>
          <a:ext cx="266721" cy="2476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4917</cdr:x>
      <cdr:y>0.10085</cdr:y>
    </cdr:from>
    <cdr:to>
      <cdr:x>0.39281</cdr:x>
      <cdr:y>0.14701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2590801" y="561975"/>
          <a:ext cx="323840" cy="2571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543</cdr:x>
      <cdr:y>0.17094</cdr:y>
    </cdr:from>
    <cdr:to>
      <cdr:x>0.38896</cdr:x>
      <cdr:y>0.22393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2628900" y="952501"/>
          <a:ext cx="257173" cy="2952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6329</cdr:x>
      <cdr:y>0.12821</cdr:y>
    </cdr:from>
    <cdr:to>
      <cdr:x>0.40565</cdr:x>
      <cdr:y>0.17436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2695575" y="714375"/>
          <a:ext cx="314337" cy="2571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409</cdr:x>
      <cdr:y>0.1282</cdr:y>
    </cdr:from>
    <cdr:to>
      <cdr:x>0.41976</cdr:x>
      <cdr:y>0.1641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2924168" y="714349"/>
          <a:ext cx="190471" cy="2000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923</cdr:x>
      <cdr:y>0.1094</cdr:y>
    </cdr:from>
    <cdr:to>
      <cdr:x>0.43646</cdr:x>
      <cdr:y>0.16068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962252" y="609607"/>
          <a:ext cx="276246" cy="2857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095</cdr:x>
      <cdr:y>0.12308</cdr:y>
    </cdr:from>
    <cdr:to>
      <cdr:x>0.44544</cdr:x>
      <cdr:y>0.18804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3038463" y="685800"/>
          <a:ext cx="266712" cy="361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03</cdr:x>
      <cdr:y>0.1094</cdr:y>
    </cdr:from>
    <cdr:to>
      <cdr:x>0.48524</cdr:x>
      <cdr:y>0.15214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3267050" y="609599"/>
          <a:ext cx="333400" cy="2381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801</cdr:x>
      <cdr:y>0.1094</cdr:y>
    </cdr:from>
    <cdr:to>
      <cdr:x>0.49294</cdr:x>
      <cdr:y>0.16581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3324231" y="609599"/>
          <a:ext cx="333369" cy="3143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57</cdr:x>
      <cdr:y>0.11111</cdr:y>
    </cdr:from>
    <cdr:to>
      <cdr:x>0.48909</cdr:x>
      <cdr:y>0.1453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3390900" y="619124"/>
          <a:ext cx="238125" cy="1905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6599</cdr:x>
      <cdr:y>0.08718</cdr:y>
    </cdr:from>
    <cdr:to>
      <cdr:x>0.53145</cdr:x>
      <cdr:y>0.1453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3457634" y="485778"/>
          <a:ext cx="485716" cy="3238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 </a:t>
          </a:r>
        </a:p>
      </cdr:txBody>
    </cdr:sp>
  </cdr:relSizeAnchor>
  <cdr:relSizeAnchor xmlns:cdr="http://schemas.openxmlformats.org/drawingml/2006/chartDrawing">
    <cdr:from>
      <cdr:x>0.49807</cdr:x>
      <cdr:y>0.37094</cdr:y>
    </cdr:from>
    <cdr:to>
      <cdr:x>0.54942</cdr:x>
      <cdr:y>0.46325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3695701" y="2066926"/>
          <a:ext cx="380982" cy="514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50578</cdr:x>
      <cdr:y>0.31624</cdr:y>
    </cdr:from>
    <cdr:to>
      <cdr:x>0.54814</cdr:x>
      <cdr:y>0.37436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752850" y="1762125"/>
          <a:ext cx="314335" cy="3238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1476</cdr:x>
      <cdr:y>0.22222</cdr:y>
    </cdr:from>
    <cdr:to>
      <cdr:x>0.58537</cdr:x>
      <cdr:y>0.28034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819525" y="1238250"/>
          <a:ext cx="523905" cy="3238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 </a:t>
          </a:r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122</cdr:x>
      <cdr:y>0.24444</cdr:y>
    </cdr:from>
    <cdr:to>
      <cdr:x>0.55841</cdr:x>
      <cdr:y>0.30598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800475" y="1362075"/>
          <a:ext cx="342913" cy="3428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276</cdr:x>
      <cdr:y>0.17094</cdr:y>
    </cdr:from>
    <cdr:to>
      <cdr:x>0.57125</cdr:x>
      <cdr:y>0.21026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3914775" y="952500"/>
          <a:ext cx="323885" cy="219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5199</cdr:x>
      <cdr:y>0.14702</cdr:y>
    </cdr:from>
    <cdr:to>
      <cdr:x>0.60334</cdr:x>
      <cdr:y>0.19659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4095727" y="819196"/>
          <a:ext cx="381016" cy="2762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8216</cdr:x>
      <cdr:y>0.09658</cdr:y>
    </cdr:from>
    <cdr:to>
      <cdr:x>0.60848</cdr:x>
      <cdr:y>0.15641</cdr:y>
    </cdr:to>
    <cdr:sp macro="" textlink="">
      <cdr:nvSpPr>
        <cdr:cNvPr id="40" name="Rettangolo 39"/>
        <cdr:cNvSpPr/>
      </cdr:nvSpPr>
      <cdr:spPr>
        <a:xfrm xmlns:a="http://schemas.openxmlformats.org/drawingml/2006/main" rot="5400000" flipV="1">
          <a:off x="4250553" y="607187"/>
          <a:ext cx="333381" cy="19529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  <a:r>
            <a:rPr lang="fr-FR">
              <a:solidFill>
                <a:sysClr val="windowText" lastClr="000000"/>
              </a:solidFill>
            </a:rPr>
            <a:t>a</a:t>
          </a:r>
        </a:p>
      </cdr:txBody>
    </cdr:sp>
  </cdr:relSizeAnchor>
  <cdr:relSizeAnchor xmlns:cdr="http://schemas.openxmlformats.org/drawingml/2006/chartDrawing">
    <cdr:from>
      <cdr:x>0.00685</cdr:x>
      <cdr:y>0.00912</cdr:y>
    </cdr:from>
    <cdr:to>
      <cdr:x>0.03765</cdr:x>
      <cdr:y>0.06895</cdr:y>
    </cdr:to>
    <cdr:sp macro="" textlink="">
      <cdr:nvSpPr>
        <cdr:cNvPr id="41" name="Rettangolo 40"/>
        <cdr:cNvSpPr/>
      </cdr:nvSpPr>
      <cdr:spPr>
        <a:xfrm xmlns:a="http://schemas.openxmlformats.org/drawingml/2006/main" rot="5400000" flipV="1">
          <a:off x="-1588" y="103188"/>
          <a:ext cx="333375" cy="2285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fr-FR">
            <a:solidFill>
              <a:sysClr val="windowText" lastClr="000000"/>
            </a:solidFill>
          </a:endParaRPr>
        </a:p>
      </cdr:txBody>
    </cdr:sp>
  </cdr:relSizeAnchor>
  <cdr:relSizeAnchor xmlns:cdr="http://schemas.openxmlformats.org/drawingml/2006/chartDrawing">
    <cdr:from>
      <cdr:x>0.57167</cdr:x>
      <cdr:y>0.08775</cdr:y>
    </cdr:from>
    <cdr:to>
      <cdr:x>0.59799</cdr:x>
      <cdr:y>0.14758</cdr:y>
    </cdr:to>
    <cdr:sp macro="" textlink="">
      <cdr:nvSpPr>
        <cdr:cNvPr id="43" name="Rettangolo 42"/>
        <cdr:cNvSpPr/>
      </cdr:nvSpPr>
      <cdr:spPr>
        <a:xfrm xmlns:a="http://schemas.openxmlformats.org/drawingml/2006/main" rot="5400000" flipV="1">
          <a:off x="4172744" y="558001"/>
          <a:ext cx="333381" cy="19529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</a:p>
      </cdr:txBody>
    </cdr:sp>
  </cdr:relSizeAnchor>
  <cdr:relSizeAnchor xmlns:cdr="http://schemas.openxmlformats.org/drawingml/2006/chartDrawing">
    <cdr:from>
      <cdr:x>0.62773</cdr:x>
      <cdr:y>0.11282</cdr:y>
    </cdr:from>
    <cdr:to>
      <cdr:x>0.65854</cdr:x>
      <cdr:y>0.16239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4657725" y="628650"/>
          <a:ext cx="22860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13479</cdr:x>
      <cdr:y>0.10769</cdr:y>
    </cdr:from>
    <cdr:to>
      <cdr:x>0.16538</cdr:x>
      <cdr:y>0.18176</cdr:y>
    </cdr:to>
    <cdr:sp macro="" textlink="">
      <cdr:nvSpPr>
        <cdr:cNvPr id="45" name="Rettangolo 44"/>
        <cdr:cNvSpPr/>
      </cdr:nvSpPr>
      <cdr:spPr>
        <a:xfrm xmlns:a="http://schemas.openxmlformats.org/drawingml/2006/main" rot="5400000" flipV="1">
          <a:off x="907255" y="692951"/>
          <a:ext cx="412738" cy="22699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</a:p>
      </cdr:txBody>
    </cdr:sp>
  </cdr:relSizeAnchor>
  <cdr:relSizeAnchor xmlns:cdr="http://schemas.openxmlformats.org/drawingml/2006/chartDrawing">
    <cdr:from>
      <cdr:x>0.07874</cdr:x>
      <cdr:y>0.13048</cdr:y>
    </cdr:from>
    <cdr:to>
      <cdr:x>0.10505</cdr:x>
      <cdr:y>0.19031</cdr:y>
    </cdr:to>
    <cdr:sp macro="" textlink="">
      <cdr:nvSpPr>
        <cdr:cNvPr id="46" name="Rettangolo 45"/>
        <cdr:cNvSpPr/>
      </cdr:nvSpPr>
      <cdr:spPr>
        <a:xfrm xmlns:a="http://schemas.openxmlformats.org/drawingml/2006/main" rot="5400000" flipV="1">
          <a:off x="515133" y="796148"/>
          <a:ext cx="333380" cy="19522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</a:p>
      </cdr:txBody>
    </cdr:sp>
  </cdr:relSizeAnchor>
  <cdr:relSizeAnchor xmlns:cdr="http://schemas.openxmlformats.org/drawingml/2006/chartDrawing">
    <cdr:from>
      <cdr:x>0.60462</cdr:x>
      <cdr:y>0.33162</cdr:y>
    </cdr:from>
    <cdr:to>
      <cdr:x>0.6855</cdr:x>
      <cdr:y>0.4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4486257" y="1847828"/>
          <a:ext cx="600127" cy="381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6226</cdr:x>
      <cdr:y>0.18803</cdr:y>
    </cdr:from>
    <cdr:to>
      <cdr:x>0.66368</cdr:x>
      <cdr:y>0.24444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4619640" y="1047733"/>
          <a:ext cx="304813" cy="3143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2902</cdr:x>
      <cdr:y>0.23248</cdr:y>
    </cdr:from>
    <cdr:to>
      <cdr:x>0.67009</cdr:x>
      <cdr:y>0.27863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4667277" y="1295404"/>
          <a:ext cx="304738" cy="2571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3415</cdr:x>
      <cdr:y>0.14701</cdr:y>
    </cdr:from>
    <cdr:to>
      <cdr:x>0.68164</cdr:x>
      <cdr:y>0.19829</cdr:y>
    </cdr:to>
    <cdr:sp macro="" textlink="">
      <cdr:nvSpPr>
        <cdr:cNvPr id="50" name="CasellaDiTesto 49"/>
        <cdr:cNvSpPr txBox="1"/>
      </cdr:nvSpPr>
      <cdr:spPr>
        <a:xfrm xmlns:a="http://schemas.openxmlformats.org/drawingml/2006/main">
          <a:off x="4705388" y="819151"/>
          <a:ext cx="352374" cy="2857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5982</cdr:x>
      <cdr:y>0.3265</cdr:y>
    </cdr:from>
    <cdr:to>
      <cdr:x>0.73171</cdr:x>
      <cdr:y>0.4</cdr:y>
    </cdr:to>
    <cdr:sp macro="" textlink="">
      <cdr:nvSpPr>
        <cdr:cNvPr id="52" name="CasellaDiTesto 51"/>
        <cdr:cNvSpPr txBox="1"/>
      </cdr:nvSpPr>
      <cdr:spPr>
        <a:xfrm xmlns:a="http://schemas.openxmlformats.org/drawingml/2006/main">
          <a:off x="4895839" y="1819295"/>
          <a:ext cx="533422" cy="4095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d</a:t>
          </a:r>
        </a:p>
      </cdr:txBody>
    </cdr:sp>
  </cdr:relSizeAnchor>
  <cdr:relSizeAnchor xmlns:cdr="http://schemas.openxmlformats.org/drawingml/2006/chartDrawing">
    <cdr:from>
      <cdr:x>0.67522</cdr:x>
      <cdr:y>0.20171</cdr:y>
    </cdr:from>
    <cdr:to>
      <cdr:x>0.74347</cdr:x>
      <cdr:y>0.27066</cdr:y>
    </cdr:to>
    <cdr:sp macro="" textlink="">
      <cdr:nvSpPr>
        <cdr:cNvPr id="54" name="Rettangolo 53"/>
        <cdr:cNvSpPr/>
      </cdr:nvSpPr>
      <cdr:spPr>
        <a:xfrm xmlns:a="http://schemas.openxmlformats.org/drawingml/2006/main" rot="5400000" flipV="1">
          <a:off x="5071263" y="1062839"/>
          <a:ext cx="384189" cy="50641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cd</a:t>
          </a:r>
        </a:p>
      </cdr:txBody>
    </cdr:sp>
  </cdr:relSizeAnchor>
  <cdr:relSizeAnchor xmlns:cdr="http://schemas.openxmlformats.org/drawingml/2006/chartDrawing">
    <cdr:from>
      <cdr:x>0.68079</cdr:x>
      <cdr:y>0.18861</cdr:y>
    </cdr:from>
    <cdr:to>
      <cdr:x>0.71652</cdr:x>
      <cdr:y>0.24844</cdr:y>
    </cdr:to>
    <cdr:sp macro="" textlink="">
      <cdr:nvSpPr>
        <cdr:cNvPr id="55" name="Rettangolo 54"/>
        <cdr:cNvSpPr/>
      </cdr:nvSpPr>
      <cdr:spPr>
        <a:xfrm xmlns:a="http://schemas.openxmlformats.org/drawingml/2006/main" rot="5400000" flipV="1">
          <a:off x="5017323" y="1085078"/>
          <a:ext cx="333380" cy="26511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bc</a:t>
          </a:r>
        </a:p>
      </cdr:txBody>
    </cdr:sp>
  </cdr:relSizeAnchor>
  <cdr:relSizeAnchor xmlns:cdr="http://schemas.openxmlformats.org/drawingml/2006/chartDrawing">
    <cdr:from>
      <cdr:x>0.69192</cdr:x>
      <cdr:y>0.17607</cdr:y>
    </cdr:from>
    <cdr:to>
      <cdr:x>0.74455</cdr:x>
      <cdr:y>0.22564</cdr:y>
    </cdr:to>
    <cdr:sp macro="" textlink="">
      <cdr:nvSpPr>
        <cdr:cNvPr id="56" name="CasellaDiTesto 55"/>
        <cdr:cNvSpPr txBox="1"/>
      </cdr:nvSpPr>
      <cdr:spPr>
        <a:xfrm xmlns:a="http://schemas.openxmlformats.org/drawingml/2006/main">
          <a:off x="5133993" y="981081"/>
          <a:ext cx="390513" cy="2762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4454</cdr:x>
      <cdr:y>0.11966</cdr:y>
    </cdr:from>
    <cdr:to>
      <cdr:x>0.76637</cdr:x>
      <cdr:y>0.14017</cdr:y>
    </cdr:to>
    <cdr:sp macro="" textlink="">
      <cdr:nvSpPr>
        <cdr:cNvPr id="57" name="CasellaDiTesto 56"/>
        <cdr:cNvSpPr txBox="1"/>
      </cdr:nvSpPr>
      <cdr:spPr>
        <a:xfrm xmlns:a="http://schemas.openxmlformats.org/drawingml/2006/main">
          <a:off x="5524500" y="666750"/>
          <a:ext cx="161925" cy="114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72529</cdr:x>
      <cdr:y>0.33162</cdr:y>
    </cdr:from>
    <cdr:to>
      <cdr:x>0.74968</cdr:x>
      <cdr:y>0.39829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5381625" y="1847850"/>
          <a:ext cx="180976" cy="3714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</a:t>
          </a:r>
        </a:p>
      </cdr:txBody>
    </cdr:sp>
  </cdr:relSizeAnchor>
  <cdr:relSizeAnchor xmlns:cdr="http://schemas.openxmlformats.org/drawingml/2006/chartDrawing">
    <cdr:from>
      <cdr:x>0.73299</cdr:x>
      <cdr:y>0.24274</cdr:y>
    </cdr:from>
    <cdr:to>
      <cdr:x>0.78562</cdr:x>
      <cdr:y>0.29402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5438786" y="1352574"/>
          <a:ext cx="390513" cy="2857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3812</cdr:x>
      <cdr:y>0.20342</cdr:y>
    </cdr:from>
    <cdr:to>
      <cdr:x>0.78819</cdr:x>
      <cdr:y>0.24616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5476842" y="1133472"/>
          <a:ext cx="371519" cy="2381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7279</cdr:x>
      <cdr:y>0.3265</cdr:y>
    </cdr:from>
    <cdr:to>
      <cdr:x>0.80231</cdr:x>
      <cdr:y>0.36411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5734101" y="1819299"/>
          <a:ext cx="219038" cy="2095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7792</cdr:x>
      <cdr:y>0.28547</cdr:y>
    </cdr:from>
    <cdr:to>
      <cdr:x>0.83055</cdr:x>
      <cdr:y>0.33504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5781655" y="1590681"/>
          <a:ext cx="381016" cy="2762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8306</cdr:x>
      <cdr:y>0.19829</cdr:y>
    </cdr:from>
    <cdr:to>
      <cdr:x>0.85623</cdr:x>
      <cdr:y>0.25299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5810249" y="1104897"/>
          <a:ext cx="542920" cy="3047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8036</cdr:x>
      <cdr:y>0.15043</cdr:y>
    </cdr:from>
    <cdr:to>
      <cdr:x>0.86522</cdr:x>
      <cdr:y>0.20684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5962656" y="838205"/>
          <a:ext cx="457218" cy="3143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267</cdr:x>
      <cdr:y>0.28889</cdr:y>
    </cdr:from>
    <cdr:to>
      <cdr:x>0.91014</cdr:x>
      <cdr:y>0.37094</cdr:y>
    </cdr:to>
    <cdr:sp macro="" textlink="">
      <cdr:nvSpPr>
        <cdr:cNvPr id="68" name="CasellaDiTesto 67"/>
        <cdr:cNvSpPr txBox="1"/>
      </cdr:nvSpPr>
      <cdr:spPr>
        <a:xfrm xmlns:a="http://schemas.openxmlformats.org/drawingml/2006/main">
          <a:off x="6134123" y="1609735"/>
          <a:ext cx="619123" cy="4571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85751</cdr:x>
      <cdr:y>0.18974</cdr:y>
    </cdr:from>
    <cdr:to>
      <cdr:x>0.92297</cdr:x>
      <cdr:y>0.25128</cdr:y>
    </cdr:to>
    <cdr:sp macro="" textlink="">
      <cdr:nvSpPr>
        <cdr:cNvPr id="69" name="CasellaDiTesto 68"/>
        <cdr:cNvSpPr txBox="1"/>
      </cdr:nvSpPr>
      <cdr:spPr>
        <a:xfrm xmlns:a="http://schemas.openxmlformats.org/drawingml/2006/main">
          <a:off x="6362732" y="1057255"/>
          <a:ext cx="485712" cy="3429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1489</cdr:x>
      <cdr:y>0.11453</cdr:y>
    </cdr:from>
    <cdr:to>
      <cdr:x>0.62516</cdr:x>
      <cdr:y>0.12991</cdr:y>
    </cdr:to>
    <cdr:sp macro="" textlink="">
      <cdr:nvSpPr>
        <cdr:cNvPr id="70" name="CasellaDiTesto 69"/>
        <cdr:cNvSpPr txBox="1"/>
      </cdr:nvSpPr>
      <cdr:spPr>
        <a:xfrm xmlns:a="http://schemas.openxmlformats.org/drawingml/2006/main">
          <a:off x="4562475" y="638175"/>
          <a:ext cx="76200" cy="857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9243</cdr:x>
      <cdr:y>0.09915</cdr:y>
    </cdr:from>
    <cdr:to>
      <cdr:x>0.12709</cdr:x>
      <cdr:y>0.14188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="" xmlns:a16="http://schemas.microsoft.com/office/drawing/2014/main" id="{536D7AC7-9672-4787-8F96-7E75F455CBFD}"/>
            </a:ext>
          </a:extLst>
        </cdr:cNvPr>
        <cdr:cNvSpPr txBox="1"/>
      </cdr:nvSpPr>
      <cdr:spPr>
        <a:xfrm xmlns:a="http://schemas.openxmlformats.org/drawingml/2006/main">
          <a:off x="685800" y="552449"/>
          <a:ext cx="257175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4891</cdr:x>
      <cdr:y>0.10256</cdr:y>
    </cdr:from>
    <cdr:to>
      <cdr:x>0.18229</cdr:x>
      <cdr:y>0.14188</cdr:y>
    </cdr:to>
    <cdr:sp macro="" textlink="">
      <cdr:nvSpPr>
        <cdr:cNvPr id="38" name="TextBox 37">
          <a:extLst xmlns:a="http://schemas.openxmlformats.org/drawingml/2006/main">
            <a:ext uri="{FF2B5EF4-FFF2-40B4-BE49-F238E27FC236}">
              <a16:creationId xmlns="" xmlns:a16="http://schemas.microsoft.com/office/drawing/2014/main" id="{0BC1F6B9-679A-4695-88D1-5EE88B4AF191}"/>
            </a:ext>
          </a:extLst>
        </cdr:cNvPr>
        <cdr:cNvSpPr txBox="1"/>
      </cdr:nvSpPr>
      <cdr:spPr>
        <a:xfrm xmlns:a="http://schemas.openxmlformats.org/drawingml/2006/main">
          <a:off x="1104900" y="571499"/>
          <a:ext cx="247650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0282</cdr:x>
      <cdr:y>0.10085</cdr:y>
    </cdr:from>
    <cdr:to>
      <cdr:x>0.23107</cdr:x>
      <cdr:y>0.13333</cdr:y>
    </cdr:to>
    <cdr:sp macro="" textlink="">
      <cdr:nvSpPr>
        <cdr:cNvPr id="39" name="TextBox 38">
          <a:extLst xmlns:a="http://schemas.openxmlformats.org/drawingml/2006/main">
            <a:ext uri="{FF2B5EF4-FFF2-40B4-BE49-F238E27FC236}">
              <a16:creationId xmlns="" xmlns:a16="http://schemas.microsoft.com/office/drawing/2014/main" id="{5BDC3BC7-514C-48DA-A719-94624765C8B6}"/>
            </a:ext>
          </a:extLst>
        </cdr:cNvPr>
        <cdr:cNvSpPr txBox="1"/>
      </cdr:nvSpPr>
      <cdr:spPr>
        <a:xfrm xmlns:a="http://schemas.openxmlformats.org/drawingml/2006/main">
          <a:off x="1504950" y="561975"/>
          <a:ext cx="209550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5931</cdr:x>
      <cdr:y>0.09915</cdr:y>
    </cdr:from>
    <cdr:to>
      <cdr:x>0.28498</cdr:x>
      <cdr:y>0.14017</cdr:y>
    </cdr:to>
    <cdr:sp macro="" textlink="">
      <cdr:nvSpPr>
        <cdr:cNvPr id="42" name="TextBox 41">
          <a:extLst xmlns:a="http://schemas.openxmlformats.org/drawingml/2006/main">
            <a:ext uri="{FF2B5EF4-FFF2-40B4-BE49-F238E27FC236}">
              <a16:creationId xmlns="" xmlns:a16="http://schemas.microsoft.com/office/drawing/2014/main" id="{CC5E0580-01B0-4BDF-BFF2-A5356D7469B7}"/>
            </a:ext>
          </a:extLst>
        </cdr:cNvPr>
        <cdr:cNvSpPr txBox="1"/>
      </cdr:nvSpPr>
      <cdr:spPr>
        <a:xfrm xmlns:a="http://schemas.openxmlformats.org/drawingml/2006/main">
          <a:off x="1924050" y="552450"/>
          <a:ext cx="1905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1322</cdr:x>
      <cdr:y>0.10256</cdr:y>
    </cdr:from>
    <cdr:to>
      <cdr:x>0.34788</cdr:x>
      <cdr:y>0.15043</cdr:y>
    </cdr:to>
    <cdr:sp macro="" textlink="">
      <cdr:nvSpPr>
        <cdr:cNvPr id="53" name="TextBox 52">
          <a:extLst xmlns:a="http://schemas.openxmlformats.org/drawingml/2006/main">
            <a:ext uri="{FF2B5EF4-FFF2-40B4-BE49-F238E27FC236}">
              <a16:creationId xmlns="" xmlns:a16="http://schemas.microsoft.com/office/drawing/2014/main" id="{966A1DCE-90A5-4FAD-860A-F32D956BA3DE}"/>
            </a:ext>
          </a:extLst>
        </cdr:cNvPr>
        <cdr:cNvSpPr txBox="1"/>
      </cdr:nvSpPr>
      <cdr:spPr>
        <a:xfrm xmlns:a="http://schemas.openxmlformats.org/drawingml/2006/main">
          <a:off x="2324099" y="571500"/>
          <a:ext cx="257175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801</cdr:x>
      <cdr:y>0.10256</cdr:y>
    </cdr:from>
    <cdr:to>
      <cdr:x>0.50834</cdr:x>
      <cdr:y>0.14188</cdr:y>
    </cdr:to>
    <cdr:sp macro="" textlink="">
      <cdr:nvSpPr>
        <cdr:cNvPr id="72" name="TextBox 71">
          <a:extLst xmlns:a="http://schemas.openxmlformats.org/drawingml/2006/main">
            <a:ext uri="{FF2B5EF4-FFF2-40B4-BE49-F238E27FC236}">
              <a16:creationId xmlns="" xmlns:a16="http://schemas.microsoft.com/office/drawing/2014/main" id="{2845C021-0931-4BA9-BFAC-131620206A3F}"/>
            </a:ext>
          </a:extLst>
        </cdr:cNvPr>
        <cdr:cNvSpPr txBox="1"/>
      </cdr:nvSpPr>
      <cdr:spPr>
        <a:xfrm xmlns:a="http://schemas.openxmlformats.org/drawingml/2006/main">
          <a:off x="3562350" y="571499"/>
          <a:ext cx="209550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3659</cdr:x>
      <cdr:y>0.10256</cdr:y>
    </cdr:from>
    <cdr:to>
      <cdr:x>0.56611</cdr:x>
      <cdr:y>0.13846</cdr:y>
    </cdr:to>
    <cdr:sp macro="" textlink="">
      <cdr:nvSpPr>
        <cdr:cNvPr id="73" name="TextBox 72">
          <a:extLst xmlns:a="http://schemas.openxmlformats.org/drawingml/2006/main">
            <a:ext uri="{FF2B5EF4-FFF2-40B4-BE49-F238E27FC236}">
              <a16:creationId xmlns="" xmlns:a16="http://schemas.microsoft.com/office/drawing/2014/main" id="{AEAFB7E2-6B02-49F0-B1CC-D149750E5F03}"/>
            </a:ext>
          </a:extLst>
        </cdr:cNvPr>
        <cdr:cNvSpPr txBox="1"/>
      </cdr:nvSpPr>
      <cdr:spPr>
        <a:xfrm xmlns:a="http://schemas.openxmlformats.org/drawingml/2006/main">
          <a:off x="3981450" y="571499"/>
          <a:ext cx="21907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6611</cdr:x>
      <cdr:y>0.11966</cdr:y>
    </cdr:from>
    <cdr:to>
      <cdr:x>0.59435</cdr:x>
      <cdr:y>0.15556</cdr:y>
    </cdr:to>
    <cdr:sp macro="" textlink="">
      <cdr:nvSpPr>
        <cdr:cNvPr id="74" name="TextBox 73">
          <a:extLst xmlns:a="http://schemas.openxmlformats.org/drawingml/2006/main">
            <a:ext uri="{FF2B5EF4-FFF2-40B4-BE49-F238E27FC236}">
              <a16:creationId xmlns="" xmlns:a16="http://schemas.microsoft.com/office/drawing/2014/main" id="{962C5B38-DBF5-4A06-9D14-4F709FDE066C}"/>
            </a:ext>
          </a:extLst>
        </cdr:cNvPr>
        <cdr:cNvSpPr txBox="1"/>
      </cdr:nvSpPr>
      <cdr:spPr>
        <a:xfrm xmlns:a="http://schemas.openxmlformats.org/drawingml/2006/main">
          <a:off x="4200526" y="666750"/>
          <a:ext cx="209550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9435</cdr:x>
      <cdr:y>0.10598</cdr:y>
    </cdr:from>
    <cdr:to>
      <cdr:x>0.638</cdr:x>
      <cdr:y>0.14701</cdr:y>
    </cdr:to>
    <cdr:sp macro="" textlink="">
      <cdr:nvSpPr>
        <cdr:cNvPr id="75" name="TextBox 74">
          <a:extLst xmlns:a="http://schemas.openxmlformats.org/drawingml/2006/main">
            <a:ext uri="{FF2B5EF4-FFF2-40B4-BE49-F238E27FC236}">
              <a16:creationId xmlns="" xmlns:a16="http://schemas.microsoft.com/office/drawing/2014/main" id="{C371B405-D43A-4872-BBA8-5478AB10B362}"/>
            </a:ext>
          </a:extLst>
        </cdr:cNvPr>
        <cdr:cNvSpPr txBox="1"/>
      </cdr:nvSpPr>
      <cdr:spPr>
        <a:xfrm xmlns:a="http://schemas.openxmlformats.org/drawingml/2006/main">
          <a:off x="4410075" y="590550"/>
          <a:ext cx="32385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457</cdr:x>
      <cdr:y>0.10256</cdr:y>
    </cdr:from>
    <cdr:to>
      <cdr:x>0.69705</cdr:x>
      <cdr:y>0.14188</cdr:y>
    </cdr:to>
    <cdr:sp macro="" textlink="">
      <cdr:nvSpPr>
        <cdr:cNvPr id="76" name="TextBox 75">
          <a:extLst xmlns:a="http://schemas.openxmlformats.org/drawingml/2006/main">
            <a:ext uri="{FF2B5EF4-FFF2-40B4-BE49-F238E27FC236}">
              <a16:creationId xmlns="" xmlns:a16="http://schemas.microsoft.com/office/drawing/2014/main" id="{6967CD8C-1569-4DD1-90D9-3F21EC48557D}"/>
            </a:ext>
          </a:extLst>
        </cdr:cNvPr>
        <cdr:cNvSpPr txBox="1"/>
      </cdr:nvSpPr>
      <cdr:spPr>
        <a:xfrm xmlns:a="http://schemas.openxmlformats.org/drawingml/2006/main">
          <a:off x="4791075" y="571500"/>
          <a:ext cx="381000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009</cdr:x>
      <cdr:y>0.10256</cdr:y>
    </cdr:from>
    <cdr:to>
      <cdr:x>0.73813</cdr:x>
      <cdr:y>0.15556</cdr:y>
    </cdr:to>
    <cdr:sp macro="" textlink="">
      <cdr:nvSpPr>
        <cdr:cNvPr id="77" name="TextBox 76">
          <a:extLst xmlns:a="http://schemas.openxmlformats.org/drawingml/2006/main">
            <a:ext uri="{FF2B5EF4-FFF2-40B4-BE49-F238E27FC236}">
              <a16:creationId xmlns="" xmlns:a16="http://schemas.microsoft.com/office/drawing/2014/main" id="{0510809F-2266-4FC2-847C-0F7D73D8945E}"/>
            </a:ext>
          </a:extLst>
        </cdr:cNvPr>
        <cdr:cNvSpPr txBox="1"/>
      </cdr:nvSpPr>
      <cdr:spPr>
        <a:xfrm xmlns:a="http://schemas.openxmlformats.org/drawingml/2006/main">
          <a:off x="5200651" y="571500"/>
          <a:ext cx="276224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163</cdr:x>
      <cdr:y>0.36581</cdr:y>
    </cdr:from>
    <cdr:to>
      <cdr:x>0.74198</cdr:x>
      <cdr:y>0.40513</cdr:y>
    </cdr:to>
    <cdr:sp macro="" textlink="">
      <cdr:nvSpPr>
        <cdr:cNvPr id="78" name="TextBox 77">
          <a:extLst xmlns:a="http://schemas.openxmlformats.org/drawingml/2006/main">
            <a:ext uri="{FF2B5EF4-FFF2-40B4-BE49-F238E27FC236}">
              <a16:creationId xmlns="" xmlns:a16="http://schemas.microsoft.com/office/drawing/2014/main" id="{B0113F63-2CE2-4864-BD04-E73A8AC47525}"/>
            </a:ext>
          </a:extLst>
        </cdr:cNvPr>
        <cdr:cNvSpPr txBox="1"/>
      </cdr:nvSpPr>
      <cdr:spPr>
        <a:xfrm xmlns:a="http://schemas.openxmlformats.org/drawingml/2006/main">
          <a:off x="5314950" y="2038349"/>
          <a:ext cx="190500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4583</cdr:x>
      <cdr:y>0.12991</cdr:y>
    </cdr:from>
    <cdr:to>
      <cdr:x>0.78691</cdr:x>
      <cdr:y>0.18632</cdr:y>
    </cdr:to>
    <cdr:sp macro="" textlink="">
      <cdr:nvSpPr>
        <cdr:cNvPr id="79" name="TextBox 78">
          <a:extLst xmlns:a="http://schemas.openxmlformats.org/drawingml/2006/main">
            <a:ext uri="{FF2B5EF4-FFF2-40B4-BE49-F238E27FC236}">
              <a16:creationId xmlns="" xmlns:a16="http://schemas.microsoft.com/office/drawing/2014/main" id="{EEC9852E-7A3E-4C53-8119-1C513CE3FB90}"/>
            </a:ext>
          </a:extLst>
        </cdr:cNvPr>
        <cdr:cNvSpPr txBox="1"/>
      </cdr:nvSpPr>
      <cdr:spPr>
        <a:xfrm xmlns:a="http://schemas.openxmlformats.org/drawingml/2006/main">
          <a:off x="5534025" y="723900"/>
          <a:ext cx="304800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5481</cdr:x>
      <cdr:y>0.10598</cdr:y>
    </cdr:from>
    <cdr:to>
      <cdr:x>0.79461</cdr:x>
      <cdr:y>0.15214</cdr:y>
    </cdr:to>
    <cdr:sp macro="" textlink="">
      <cdr:nvSpPr>
        <cdr:cNvPr id="80" name="TextBox 79">
          <a:extLst xmlns:a="http://schemas.openxmlformats.org/drawingml/2006/main">
            <a:ext uri="{FF2B5EF4-FFF2-40B4-BE49-F238E27FC236}">
              <a16:creationId xmlns="" xmlns:a16="http://schemas.microsoft.com/office/drawing/2014/main" id="{2D7FFA1A-10CE-4F72-9A6B-A69AAC988A1C}"/>
            </a:ext>
          </a:extLst>
        </cdr:cNvPr>
        <cdr:cNvSpPr txBox="1"/>
      </cdr:nvSpPr>
      <cdr:spPr>
        <a:xfrm xmlns:a="http://schemas.openxmlformats.org/drawingml/2006/main">
          <a:off x="5600699" y="590550"/>
          <a:ext cx="295275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0873</cdr:x>
      <cdr:y>0.10427</cdr:y>
    </cdr:from>
    <cdr:to>
      <cdr:x>0.85109</cdr:x>
      <cdr:y>0.15556</cdr:y>
    </cdr:to>
    <cdr:sp macro="" textlink="">
      <cdr:nvSpPr>
        <cdr:cNvPr id="81" name="TextBox 80">
          <a:extLst xmlns:a="http://schemas.openxmlformats.org/drawingml/2006/main">
            <a:ext uri="{FF2B5EF4-FFF2-40B4-BE49-F238E27FC236}">
              <a16:creationId xmlns="" xmlns:a16="http://schemas.microsoft.com/office/drawing/2014/main" id="{C95D15D6-7CEF-4968-A009-4966A7EBF62F}"/>
            </a:ext>
          </a:extLst>
        </cdr:cNvPr>
        <cdr:cNvSpPr txBox="1"/>
      </cdr:nvSpPr>
      <cdr:spPr>
        <a:xfrm xmlns:a="http://schemas.openxmlformats.org/drawingml/2006/main">
          <a:off x="6000750" y="581025"/>
          <a:ext cx="31432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6521</cdr:x>
      <cdr:y>0.10085</cdr:y>
    </cdr:from>
    <cdr:to>
      <cdr:x>0.91784</cdr:x>
      <cdr:y>0.15726</cdr:y>
    </cdr:to>
    <cdr:sp macro="" textlink="">
      <cdr:nvSpPr>
        <cdr:cNvPr id="82" name="TextBox 81">
          <a:extLst xmlns:a="http://schemas.openxmlformats.org/drawingml/2006/main">
            <a:ext uri="{FF2B5EF4-FFF2-40B4-BE49-F238E27FC236}">
              <a16:creationId xmlns="" xmlns:a16="http://schemas.microsoft.com/office/drawing/2014/main" id="{65320B53-1320-42F9-B2CD-D5B21E4CD722}"/>
            </a:ext>
          </a:extLst>
        </cdr:cNvPr>
        <cdr:cNvSpPr txBox="1"/>
      </cdr:nvSpPr>
      <cdr:spPr>
        <a:xfrm xmlns:a="http://schemas.openxmlformats.org/drawingml/2006/main">
          <a:off x="6419849" y="561974"/>
          <a:ext cx="3905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5899951" y="0"/>
            <a:ext cx="32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smtClean="0"/>
              <a:t>Fluconazole</a:t>
            </a:r>
            <a:endParaRPr lang="en-GB" b="1" dirty="0"/>
          </a:p>
        </p:txBody>
      </p:sp>
      <p:graphicFrame>
        <p:nvGraphicFramePr>
          <p:cNvPr id="3" name="Grafico 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2570815"/>
              </p:ext>
            </p:extLst>
          </p:nvPr>
        </p:nvGraphicFramePr>
        <p:xfrm>
          <a:off x="251520" y="762000"/>
          <a:ext cx="8352928" cy="5979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934991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</TotalTime>
  <Words>75</Words>
  <Application>Microsoft Office PowerPoint</Application>
  <PresentationFormat>Presentazione su schermo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5</cp:revision>
  <dcterms:created xsi:type="dcterms:W3CDTF">2019-06-04T18:45:56Z</dcterms:created>
  <dcterms:modified xsi:type="dcterms:W3CDTF">2019-08-20T09:20:40Z</dcterms:modified>
</cp:coreProperties>
</file>